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5B7301-F63F-450F-9EA1-0423FC0A089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53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dditional Figure 2:  Hazard ratios of PR+ and PR- tumors for increased BMI</a:t>
            </a:r>
            <a:r>
              <a:rPr b="1" lang="en-US" sz="12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cross 5-year age-bands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lide Number Placehold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FB1534-3997-45B1-A709-6717CF5A135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610D5-B1E8-40DA-8B6E-E8E0BC82B1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21FE6-53B5-4A59-A11D-ADE816515B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3D9D4-EAA7-4474-AB2A-F42122E568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5718F-7BFA-436E-A5A8-4585D84105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F98E8-CBF1-47C0-BDA0-7A21474A0B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212B6-7155-43B1-B457-ABE6E5E98A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8701C-DEFE-44D1-8CFE-8B001F91D2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D08EE-E894-4101-88C8-B76C0E67FE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28EFA-9FF3-4CEA-B178-195DF0FD49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B75D7-F1EA-4717-B6D5-3BD4CBC4EB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751B5-E651-4336-AA6E-AB95B2A32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F4BDF-6992-4736-B0D4-0343C09AC3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707821-B5A8-442F-B8A9-BF6CFA42063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5"/>
          <p:cNvSpPr/>
          <p:nvPr/>
        </p:nvSpPr>
        <p:spPr>
          <a:xfrm>
            <a:off x="144360" y="1674720"/>
            <a:ext cx="8926560" cy="3673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2"/>
          <p:cNvSpPr/>
          <p:nvPr/>
        </p:nvSpPr>
        <p:spPr>
          <a:xfrm>
            <a:off x="438120" y="4786200"/>
            <a:ext cx="8447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igure s2  Hazard ratios of PR-positive and PR-negative tumors for increased BMI</a:t>
            </a:r>
            <a:r>
              <a:rPr b="1" lang="en-US" sz="1000" spc="-1" strike="noStrike" baseline="30000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across 5-year age-bands.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All models are for a 5 kg/m</a:t>
            </a:r>
            <a:r>
              <a:rPr b="0" lang="en-US" sz="1000" spc="-1" strike="noStrike" baseline="30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 increase in BMI and were stratified by age at recruitment and study center. Hazard ratio estimates are shown for all women and HRT never users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Chart 7" descr=""/>
          <p:cNvPicPr/>
          <p:nvPr/>
        </p:nvPicPr>
        <p:blipFill>
          <a:blip r:embed="rId1"/>
          <a:stretch/>
        </p:blipFill>
        <p:spPr>
          <a:xfrm>
            <a:off x="212760" y="2066760"/>
            <a:ext cx="5005440" cy="2743200"/>
          </a:xfrm>
          <a:prstGeom prst="rect">
            <a:avLst/>
          </a:prstGeom>
          <a:ln w="0">
            <a:noFill/>
          </a:ln>
        </p:spPr>
      </p:pic>
      <p:pic>
        <p:nvPicPr>
          <p:cNvPr id="51" name="Chart 8" descr=""/>
          <p:cNvPicPr/>
          <p:nvPr/>
        </p:nvPicPr>
        <p:blipFill>
          <a:blip r:embed="rId2"/>
          <a:stretch/>
        </p:blipFill>
        <p:spPr>
          <a:xfrm>
            <a:off x="3981600" y="2041560"/>
            <a:ext cx="5003640" cy="273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8T11:43:57Z</dcterms:created>
  <dc:creator>James, Rebecca</dc:creator>
  <dc:description/>
  <dc:language>en-US</dc:language>
  <cp:lastModifiedBy>Rebecca Ritte</cp:lastModifiedBy>
  <cp:lastPrinted>2011-12-13T11:51:43Z</cp:lastPrinted>
  <dcterms:modified xsi:type="dcterms:W3CDTF">2012-05-10T09:10:25Z</dcterms:modified>
  <cp:revision>46</cp:revision>
  <dc:subject/>
  <dc:title>PowerPoint Presentation</dc:title>
</cp:coreProperties>
</file>